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4674"/>
  </p:normalViewPr>
  <p:slideViewPr>
    <p:cSldViewPr snapToGrid="0" snapToObjects="1">
      <p:cViewPr varScale="1">
        <p:scale>
          <a:sx n="131" d="100"/>
          <a:sy n="131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BF5729-D6B8-704D-98B1-6BCD1545F1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8A5B543-C995-C94B-A797-82D35A6770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4DD3EE-BD6F-0D48-859C-CF4FD841F6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333F-2871-394E-8674-3A632C190812}" type="datetimeFigureOut">
              <a:rPr lang="en-US" smtClean="0"/>
              <a:t>6/1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3DF592-C4C1-A74E-8DFA-895CA1A47B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5CF4A2-F8AD-1047-BCA9-3C716D5919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DEDAF-7050-A741-816F-B9B2543F0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87808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F85A73-F10D-0D49-A951-A308552B00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811FBB7-0434-DA4B-ADBC-8C08572252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1B6F37-CD62-6344-8962-4B8582C2AF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333F-2871-394E-8674-3A632C190812}" type="datetimeFigureOut">
              <a:rPr lang="en-US" smtClean="0"/>
              <a:t>6/1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9BB0A2-F1EE-6645-B936-7BD4513306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CB9D79-45A1-D74F-8902-A1ECFE1017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DEDAF-7050-A741-816F-B9B2543F0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23324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353919E-F18A-224B-BD2D-CB51C286A2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1F26363-579D-BF49-9379-8AF9E01708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53BED8-A3F5-5840-94CF-696F4F47AF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333F-2871-394E-8674-3A632C190812}" type="datetimeFigureOut">
              <a:rPr lang="en-US" smtClean="0"/>
              <a:t>6/1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47EE85-B89A-CC4F-B9A3-BE3D4ED4D2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658B2E-B264-A34A-98B5-7B07D85DEE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DEDAF-7050-A741-816F-B9B2543F0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988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7040FA-DB44-2C43-A1D0-2CF4926E50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568504-E08F-B74A-AAF0-7B0EF92EE09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C1EE32-7BB7-5447-B66E-E867DF14DF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333F-2871-394E-8674-3A632C190812}" type="datetimeFigureOut">
              <a:rPr lang="en-US" smtClean="0"/>
              <a:t>6/1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FF5707-575A-8741-92CA-562039A649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DD228B-CE51-9E4B-83ED-DF96CF696E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DEDAF-7050-A741-816F-B9B2543F0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2553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081289-B6BB-8B48-B0AE-42CDC9109B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F81FB8-6D5E-284F-853B-2F6EB6F077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425CDB-4077-D548-905A-636E89022B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333F-2871-394E-8674-3A632C190812}" type="datetimeFigureOut">
              <a:rPr lang="en-US" smtClean="0"/>
              <a:t>6/1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4B64FF-F78F-544A-8A3A-2926CD1F77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718A1C-5EA7-3844-8F89-06BA3223D9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DEDAF-7050-A741-816F-B9B2543F0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54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A38519-B0BD-724A-9B8B-AF86B1F4C9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5A4FF6-180B-F540-B63F-F64D0CC27E0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D96854F-EABA-6549-9B35-93D25FFBFE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59BA9D-B844-7740-B9A5-9E817FA5A7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333F-2871-394E-8674-3A632C190812}" type="datetimeFigureOut">
              <a:rPr lang="en-US" smtClean="0"/>
              <a:t>6/1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C37376-5DFB-8A4A-9973-E7D837473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102E67-9B06-224B-B545-BD1666FBD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DEDAF-7050-A741-816F-B9B2543F0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305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DAA47D-C721-B541-8DCE-C1D0347A80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75DEE0-3C32-9845-9B6F-C7DEE861AE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08948C-17C3-B149-8801-E8669CDCEF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BC65530-0BEE-5F4C-ADDD-5E168F69642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FD3E6DA-E1E4-884B-80E2-DA93A4C3A6C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8701BBA-6246-7C49-BC08-A72CCC235A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333F-2871-394E-8674-3A632C190812}" type="datetimeFigureOut">
              <a:rPr lang="en-US" smtClean="0"/>
              <a:t>6/11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44E5361-7249-0447-9B88-56A5A39F7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27DA881-3133-344A-A322-20782175E3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DEDAF-7050-A741-816F-B9B2543F0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9105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B579B1-7B7C-8E41-A512-5800FBAF9C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04DDA87-9D0F-7247-A850-A84B3C00DA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333F-2871-394E-8674-3A632C190812}" type="datetimeFigureOut">
              <a:rPr lang="en-US" smtClean="0"/>
              <a:t>6/11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B622B59-8F2A-B94E-B35A-1847D94941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66827C8-D2FF-1248-8FBB-76A1443A33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DEDAF-7050-A741-816F-B9B2543F0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5775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7549DDD-9B44-BC47-B960-7F0839E2EF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333F-2871-394E-8674-3A632C190812}" type="datetimeFigureOut">
              <a:rPr lang="en-US" smtClean="0"/>
              <a:t>6/11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E2B6A6A-FAF6-BB42-9643-103EE350D2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B7C6741-178D-CA42-B9B1-909636326F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DEDAF-7050-A741-816F-B9B2543F0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1323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F9D59E-499B-774B-84B5-E6F01EBE81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2FB714-D598-0B43-B1A7-AA5DCE44728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3E002E-5A7C-A246-A35F-AF182CB4D2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451CBD6-4028-FC4C-B96E-A4C2E523A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333F-2871-394E-8674-3A632C190812}" type="datetimeFigureOut">
              <a:rPr lang="en-US" smtClean="0"/>
              <a:t>6/1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DAC439-AFB8-FC4B-953A-0F3EBBA941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15469D-3DB3-3249-BAEC-3A254A32E7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DEDAF-7050-A741-816F-B9B2543F0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8855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DB34B7-AE1A-EC48-A9B6-7F42D13131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F6DD50E-AADA-9646-AA0D-A6CE3F36818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50A55F-9156-2A49-A6AE-EBA94DE11C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AE7352-0EFB-9941-94BD-E328B7C9E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333F-2871-394E-8674-3A632C190812}" type="datetimeFigureOut">
              <a:rPr lang="en-US" smtClean="0"/>
              <a:t>6/1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46B6A7-9B06-0D40-8C43-30E09DB966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303B49-29F5-0B49-8C73-7059745D15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2DEDAF-7050-A741-816F-B9B2543F0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1057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E123A1D-ACD8-3541-87A2-E0672755A0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1B38F9-5D10-384C-A4C6-AB23CD2109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35365A-211F-DB4C-923B-E28937CA23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0C333F-2871-394E-8674-3A632C190812}" type="datetimeFigureOut">
              <a:rPr lang="en-US" smtClean="0"/>
              <a:t>6/1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0D0E2E-36F7-ED4D-99DF-8A90CFEA290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56841A-3C6A-EF48-8119-F34C0F4F74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2DEDAF-7050-A741-816F-B9B2543F0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496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/>
          <p:cNvSpPr/>
          <p:nvPr/>
        </p:nvSpPr>
        <p:spPr>
          <a:xfrm>
            <a:off x="420139" y="252225"/>
            <a:ext cx="830199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맑은 고딕" panose="020B0503020000020004" pitchFamily="50" charset="-127"/>
                <a:cs typeface="+mn-cs"/>
              </a:rPr>
              <a:t>Table S3. </a:t>
            </a:r>
            <a:r>
              <a:rPr kumimoji="0" lang="en-US" altLang="ko-KR" sz="18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맑은 고딕" panose="020B0503020000020004" pitchFamily="50" charset="-127"/>
                <a:cs typeface="+mn-cs"/>
              </a:rPr>
              <a:t>In vivo </a:t>
            </a:r>
            <a:r>
              <a:rPr kumimoji="0" lang="en-US" altLang="ko-K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맑은 고딕" panose="020B0503020000020004" pitchFamily="50" charset="-127"/>
                <a:cs typeface="+mn-cs"/>
              </a:rPr>
              <a:t>safety pharmacology and repeat toxicity</a:t>
            </a:r>
            <a:r>
              <a:rPr kumimoji="0" lang="en-US" altLang="ko-KR" sz="1800" b="1" i="0" u="none" strike="noStrike" kern="12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맑은 고딕" panose="020B0503020000020004" pitchFamily="50" charset="-127"/>
                <a:cs typeface="+mn-cs"/>
              </a:rPr>
              <a:t> of STP0404</a:t>
            </a:r>
            <a:endParaRPr kumimoji="0" lang="en-US" altLang="ko-KR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맑은 고딕" panose="020B0503020000020004" pitchFamily="50" charset="-127"/>
              <a:cs typeface="+mn-cs"/>
            </a:endParaRPr>
          </a:p>
        </p:txBody>
      </p:sp>
      <p:graphicFrame>
        <p:nvGraphicFramePr>
          <p:cNvPr id="3" name="표 2"/>
          <p:cNvGraphicFramePr>
            <a:graphicFrameLocks noGrp="1"/>
          </p:cNvGraphicFramePr>
          <p:nvPr/>
        </p:nvGraphicFramePr>
        <p:xfrm>
          <a:off x="420139" y="670197"/>
          <a:ext cx="8981556" cy="597599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946434">
                  <a:extLst>
                    <a:ext uri="{9D8B030D-6E8A-4147-A177-3AD203B41FA5}">
                      <a16:colId xmlns:a16="http://schemas.microsoft.com/office/drawing/2014/main" val="4234137312"/>
                    </a:ext>
                  </a:extLst>
                </a:gridCol>
                <a:gridCol w="1274866">
                  <a:extLst>
                    <a:ext uri="{9D8B030D-6E8A-4147-A177-3AD203B41FA5}">
                      <a16:colId xmlns:a16="http://schemas.microsoft.com/office/drawing/2014/main" val="3453152319"/>
                    </a:ext>
                  </a:extLst>
                </a:gridCol>
                <a:gridCol w="1274866">
                  <a:extLst>
                    <a:ext uri="{9D8B030D-6E8A-4147-A177-3AD203B41FA5}">
                      <a16:colId xmlns:a16="http://schemas.microsoft.com/office/drawing/2014/main" val="3390488093"/>
                    </a:ext>
                  </a:extLst>
                </a:gridCol>
                <a:gridCol w="4485390">
                  <a:extLst>
                    <a:ext uri="{9D8B030D-6E8A-4147-A177-3AD203B41FA5}">
                      <a16:colId xmlns:a16="http://schemas.microsoft.com/office/drawing/2014/main" val="1840656862"/>
                    </a:ext>
                  </a:extLst>
                </a:gridCol>
              </a:tblGrid>
              <a:tr h="389394">
                <a:tc gridSpan="4"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fety Pharmacology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81712839"/>
                  </a:ext>
                </a:extLst>
              </a:tr>
              <a:tr h="63132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piratory system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 Rat: 100, 300, 600 mg/kg/day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TP0404 had no effects on the respiratory system in rats at single oral dose levels up to 600 mg/kg. </a:t>
                      </a:r>
                      <a:r>
                        <a:rPr lang="en-US" altLang="ko-KR" sz="12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OEL</a:t>
                      </a:r>
                      <a:r>
                        <a:rPr lang="en-US" altLang="ko-KR" sz="12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is thus </a:t>
                      </a:r>
                      <a:r>
                        <a:rPr lang="en-US" altLang="ko-KR" sz="12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00 mg/kg</a:t>
                      </a:r>
                      <a:r>
                        <a:rPr lang="en-US" altLang="ko-KR" sz="12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.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81160667"/>
                  </a:ext>
                </a:extLst>
              </a:tr>
              <a:tr h="63132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tral</a:t>
                      </a:r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ervous system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 Rat: 100, 300, 600 mg/kg/day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TP0404 had no effect on the CNS in rats following a single oral dose up to 600 mg/kg. Therefore </a:t>
                      </a:r>
                      <a:r>
                        <a:rPr lang="en-US" altLang="ko-KR" sz="12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00 mg/kg</a:t>
                      </a:r>
                      <a:r>
                        <a:rPr lang="en-US" altLang="ko-KR" sz="12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is considered to be the </a:t>
                      </a:r>
                      <a:r>
                        <a:rPr lang="en-US" altLang="ko-KR" sz="12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OEL</a:t>
                      </a:r>
                      <a:r>
                        <a:rPr lang="en-US" altLang="ko-KR" sz="12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in this study.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83482834"/>
                  </a:ext>
                </a:extLst>
              </a:tr>
              <a:tr h="63132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iovascular</a:t>
                      </a:r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ystem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:</a:t>
                      </a:r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30, 60,90 mg/kg/day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TP0404 had no effect on the cardiovascular system in dogs following a single oral dose up to 90 mg/kg. Therefore </a:t>
                      </a:r>
                      <a:r>
                        <a:rPr lang="en-US" altLang="ko-KR" sz="12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0 mg/kg</a:t>
                      </a:r>
                      <a:r>
                        <a:rPr lang="en-US" altLang="ko-KR" sz="12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is considered to be the </a:t>
                      </a:r>
                      <a:r>
                        <a:rPr lang="en-US" altLang="ko-KR" sz="12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OEL</a:t>
                      </a:r>
                      <a:r>
                        <a:rPr lang="en-US" altLang="ko-KR" sz="12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in this study.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27185841"/>
                  </a:ext>
                </a:extLst>
              </a:tr>
              <a:tr h="389394">
                <a:tc gridSpan="4">
                  <a:txBody>
                    <a:bodyPr/>
                    <a:lstStyle/>
                    <a:p>
                      <a:pPr latinLnBrk="1"/>
                      <a:r>
                        <a:rPr lang="en-US" altLang="ko-KR" sz="12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otoxicity</a:t>
                      </a: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tudies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33327312"/>
                  </a:ext>
                </a:extLst>
              </a:tr>
              <a:tr h="38939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terial</a:t>
                      </a:r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verse Mutation</a:t>
                      </a:r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est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100, TA1535, WP2uvrA, TA98,</a:t>
                      </a:r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A1537 strains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P0404 was considered nit to</a:t>
                      </a:r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ossess any gene mutation-including potential in any of the 5 bacterial strains tested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869662002"/>
                  </a:ext>
                </a:extLst>
              </a:tr>
              <a:tr h="38939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omosomal Aberration Test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L/IU cells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P0404 was considered not to possess the potential to induce chromosomal aberrations</a:t>
                      </a:r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n CHL/IU cells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943475727"/>
                  </a:ext>
                </a:extLst>
              </a:tr>
              <a:tr h="38939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ronucleus study  in Rats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0, 1000, 2000 mg/kg/day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P0404 was considered not to possess the in vivo potential to induce chromosomal aberrations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84234539"/>
                  </a:ext>
                </a:extLst>
              </a:tr>
              <a:tr h="389394">
                <a:tc gridSpan="4"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EAL in 4-Week GLP Toxicology</a:t>
                      </a:r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tudies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59570928"/>
                  </a:ext>
                </a:extLst>
              </a:tr>
              <a:tr h="418689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es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s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s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28077145"/>
                  </a:ext>
                </a:extLst>
              </a:tr>
              <a:tr h="38939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 (4w</a:t>
                      </a:r>
                      <a:r>
                        <a:rPr lang="en-US" altLang="ko-KR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 R2w)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300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TP0404 </a:t>
                      </a:r>
                      <a:r>
                        <a:rPr lang="en-US" altLang="ko-KR" sz="12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OAEL</a:t>
                      </a:r>
                      <a:r>
                        <a:rPr lang="en-US" altLang="ko-KR" sz="12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was considered to be </a:t>
                      </a:r>
                      <a:r>
                        <a:rPr lang="en-US" altLang="ko-KR" sz="12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00 mg/kg/day for males and 600 mg/kg/day for females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94346804"/>
                  </a:ext>
                </a:extLst>
              </a:tr>
              <a:tr h="38939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 (4w + R2w)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o toxic changes were noted at any dose level. </a:t>
                      </a:r>
                      <a:r>
                        <a:rPr lang="en-US" altLang="ko-KR" sz="12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OAEL</a:t>
                      </a:r>
                      <a:r>
                        <a:rPr lang="en-US" altLang="ko-KR" sz="12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f STP0404 was </a:t>
                      </a:r>
                      <a:r>
                        <a:rPr lang="en-US" altLang="ko-KR" sz="12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0 mg/kg/day for both males and females</a:t>
                      </a:r>
                      <a:r>
                        <a:rPr lang="en-US" altLang="ko-KR" sz="12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under the conditions of this study.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192073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380152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6</Words>
  <Application>Microsoft Macintosh PowerPoint</Application>
  <PresentationFormat>Widescreen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</cp:revision>
  <dcterms:created xsi:type="dcterms:W3CDTF">2021-06-11T16:28:34Z</dcterms:created>
  <dcterms:modified xsi:type="dcterms:W3CDTF">2021-06-11T16:29:19Z</dcterms:modified>
</cp:coreProperties>
</file>